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12192000" cy="1440021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672" autoAdjust="0"/>
    <p:restoredTop sz="94660"/>
  </p:normalViewPr>
  <p:slideViewPr>
    <p:cSldViewPr snapToGrid="0">
      <p:cViewPr>
        <p:scale>
          <a:sx n="125" d="100"/>
          <a:sy n="125" d="100"/>
        </p:scale>
        <p:origin x="56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6703"/>
            <a:ext cx="10363200" cy="50134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63446"/>
            <a:ext cx="9144000" cy="347671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4367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5474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6678"/>
            <a:ext cx="2628900" cy="1220351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6678"/>
            <a:ext cx="7734300" cy="1220351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1781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4820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0057"/>
            <a:ext cx="10515600" cy="599008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36813"/>
            <a:ext cx="10515600" cy="315004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1578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3390"/>
            <a:ext cx="5181600" cy="913680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3390"/>
            <a:ext cx="5181600" cy="913680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557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6681"/>
            <a:ext cx="10515600" cy="27833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0053"/>
            <a:ext cx="5157787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0078"/>
            <a:ext cx="5157787" cy="773678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0053"/>
            <a:ext cx="5183188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0078"/>
            <a:ext cx="5183188" cy="773678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0977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5411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785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3367"/>
            <a:ext cx="6172200" cy="10233485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191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3367"/>
            <a:ext cx="6172200" cy="10233485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8038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6681"/>
            <a:ext cx="105156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3390"/>
            <a:ext cx="105156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C8339-DA22-42DB-AF29-A2711A3E6295}" type="datetimeFigureOut">
              <a:rPr lang="en-GB" smtClean="0"/>
              <a:t>11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46867"/>
            <a:ext cx="41148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0503C-C987-4101-8A16-F93FA968BC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789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3360" y="2035"/>
            <a:ext cx="7762875" cy="1733550"/>
          </a:xfrm>
          <a:prstGeom prst="rect">
            <a:avLst/>
          </a:prstGeom>
        </p:spPr>
      </p:pic>
      <p:sp>
        <p:nvSpPr>
          <p:cNvPr id="62" name="TextBox 61"/>
          <p:cNvSpPr txBox="1"/>
          <p:nvPr/>
        </p:nvSpPr>
        <p:spPr>
          <a:xfrm>
            <a:off x="33309" y="-748"/>
            <a:ext cx="332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7" name="TextBox 156"/>
          <p:cNvSpPr txBox="1"/>
          <p:nvPr/>
        </p:nvSpPr>
        <p:spPr>
          <a:xfrm rot="16200000">
            <a:off x="36851" y="377405"/>
            <a:ext cx="9652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pth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3700213" y="2436920"/>
            <a:ext cx="3322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8088707" y="290576"/>
            <a:ext cx="10305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TextBox 303"/>
          <p:cNvSpPr txBox="1"/>
          <p:nvPr/>
        </p:nvSpPr>
        <p:spPr>
          <a:xfrm>
            <a:off x="8079733" y="725353"/>
            <a:ext cx="1449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teosarcoma</a:t>
            </a:r>
            <a:endParaRPr lang="en-GB" sz="1400" dirty="0">
              <a:solidFill>
                <a:srgbClr val="FF99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TextBox 305"/>
          <p:cNvSpPr txBox="1"/>
          <p:nvPr/>
        </p:nvSpPr>
        <p:spPr>
          <a:xfrm>
            <a:off x="9448865" y="842999"/>
            <a:ext cx="193492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GFOD2</a:t>
            </a:r>
          </a:p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Skipped 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xon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TextBox 307"/>
          <p:cNvSpPr txBox="1"/>
          <p:nvPr/>
        </p:nvSpPr>
        <p:spPr>
          <a:xfrm>
            <a:off x="1132114" y="3367698"/>
            <a:ext cx="221459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TG4D</a:t>
            </a:r>
          </a:p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Retained Intron)</a:t>
            </a:r>
            <a:endParaRPr lang="en-GB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TextBox 316"/>
          <p:cNvSpPr txBox="1"/>
          <p:nvPr/>
        </p:nvSpPr>
        <p:spPr>
          <a:xfrm>
            <a:off x="33309" y="4944294"/>
            <a:ext cx="3004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19" name="TextBox 318"/>
          <p:cNvSpPr txBox="1"/>
          <p:nvPr/>
        </p:nvSpPr>
        <p:spPr>
          <a:xfrm>
            <a:off x="8890573" y="6204813"/>
            <a:ext cx="305993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PM1</a:t>
            </a:r>
          </a:p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5’ Alternative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lice Site)</a:t>
            </a:r>
            <a:endParaRPr lang="en-GB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132114" y="1655634"/>
            <a:ext cx="865532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TextBox 329"/>
          <p:cNvSpPr txBox="1"/>
          <p:nvPr/>
        </p:nvSpPr>
        <p:spPr>
          <a:xfrm>
            <a:off x="1132114" y="2057577"/>
            <a:ext cx="865532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TextBox 330"/>
          <p:cNvSpPr txBox="1"/>
          <p:nvPr/>
        </p:nvSpPr>
        <p:spPr>
          <a:xfrm>
            <a:off x="3966999" y="2056442"/>
            <a:ext cx="865532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TextBox 331"/>
          <p:cNvSpPr txBox="1"/>
          <p:nvPr/>
        </p:nvSpPr>
        <p:spPr>
          <a:xfrm>
            <a:off x="7175117" y="1659976"/>
            <a:ext cx="865532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TextBox 332"/>
          <p:cNvSpPr txBox="1"/>
          <p:nvPr/>
        </p:nvSpPr>
        <p:spPr>
          <a:xfrm>
            <a:off x="7175117" y="2061919"/>
            <a:ext cx="865532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/>
          <p:cNvCxnSpPr>
            <a:stCxn id="20" idx="3"/>
            <a:endCxn id="332" idx="1"/>
          </p:cNvCxnSpPr>
          <p:nvPr/>
        </p:nvCxnSpPr>
        <p:spPr>
          <a:xfrm>
            <a:off x="1997646" y="1809523"/>
            <a:ext cx="5177471" cy="43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4" name="Straight Connector 333"/>
          <p:cNvCxnSpPr>
            <a:stCxn id="330" idx="3"/>
            <a:endCxn id="331" idx="1"/>
          </p:cNvCxnSpPr>
          <p:nvPr/>
        </p:nvCxnSpPr>
        <p:spPr>
          <a:xfrm flipV="1">
            <a:off x="1997646" y="2210331"/>
            <a:ext cx="1969353" cy="11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5" name="Straight Connector 334"/>
          <p:cNvCxnSpPr>
            <a:stCxn id="331" idx="3"/>
            <a:endCxn id="333" idx="1"/>
          </p:cNvCxnSpPr>
          <p:nvPr/>
        </p:nvCxnSpPr>
        <p:spPr>
          <a:xfrm>
            <a:off x="4832531" y="2210331"/>
            <a:ext cx="2342586" cy="54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2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0649" y="2509937"/>
            <a:ext cx="7620000" cy="1724025"/>
          </a:xfrm>
          <a:prstGeom prst="rect">
            <a:avLst/>
          </a:prstGeom>
        </p:spPr>
      </p:pic>
      <p:sp>
        <p:nvSpPr>
          <p:cNvPr id="336" name="TextBox 335"/>
          <p:cNvSpPr txBox="1"/>
          <p:nvPr/>
        </p:nvSpPr>
        <p:spPr>
          <a:xfrm rot="16200000">
            <a:off x="3642329" y="2882196"/>
            <a:ext cx="9652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pth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TextBox 336"/>
          <p:cNvSpPr txBox="1"/>
          <p:nvPr/>
        </p:nvSpPr>
        <p:spPr>
          <a:xfrm>
            <a:off x="10725979" y="2467697"/>
            <a:ext cx="10305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TextBox 337"/>
          <p:cNvSpPr txBox="1"/>
          <p:nvPr/>
        </p:nvSpPr>
        <p:spPr>
          <a:xfrm>
            <a:off x="10149625" y="2997181"/>
            <a:ext cx="1449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teosarcoma</a:t>
            </a:r>
            <a:endParaRPr lang="en-GB" sz="1400" dirty="0">
              <a:solidFill>
                <a:srgbClr val="FF99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TextBox 340"/>
          <p:cNvSpPr txBox="1"/>
          <p:nvPr/>
        </p:nvSpPr>
        <p:spPr>
          <a:xfrm>
            <a:off x="4671950" y="4238196"/>
            <a:ext cx="6834249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Box 341"/>
          <p:cNvSpPr txBox="1"/>
          <p:nvPr/>
        </p:nvSpPr>
        <p:spPr>
          <a:xfrm>
            <a:off x="4671950" y="4640139"/>
            <a:ext cx="4573649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TextBox 342"/>
          <p:cNvSpPr txBox="1"/>
          <p:nvPr/>
        </p:nvSpPr>
        <p:spPr>
          <a:xfrm>
            <a:off x="10452100" y="4635476"/>
            <a:ext cx="1054099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4" name="Straight Connector 343"/>
          <p:cNvCxnSpPr>
            <a:stCxn id="342" idx="3"/>
            <a:endCxn id="343" idx="1"/>
          </p:cNvCxnSpPr>
          <p:nvPr/>
        </p:nvCxnSpPr>
        <p:spPr>
          <a:xfrm flipV="1">
            <a:off x="9245599" y="4789365"/>
            <a:ext cx="1206501" cy="466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Picture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0972" y="5128960"/>
            <a:ext cx="7867650" cy="1695450"/>
          </a:xfrm>
          <a:prstGeom prst="rect">
            <a:avLst/>
          </a:prstGeom>
        </p:spPr>
      </p:pic>
      <p:sp>
        <p:nvSpPr>
          <p:cNvPr id="345" name="TextBox 344"/>
          <p:cNvSpPr txBox="1"/>
          <p:nvPr/>
        </p:nvSpPr>
        <p:spPr>
          <a:xfrm rot="16200000">
            <a:off x="36851" y="5455988"/>
            <a:ext cx="9652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pth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TextBox 345"/>
          <p:cNvSpPr txBox="1"/>
          <p:nvPr/>
        </p:nvSpPr>
        <p:spPr>
          <a:xfrm>
            <a:off x="1132114" y="6783577"/>
            <a:ext cx="865532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TextBox 346"/>
          <p:cNvSpPr txBox="1"/>
          <p:nvPr/>
        </p:nvSpPr>
        <p:spPr>
          <a:xfrm>
            <a:off x="1132114" y="7185520"/>
            <a:ext cx="865532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TextBox 348"/>
          <p:cNvSpPr txBox="1"/>
          <p:nvPr/>
        </p:nvSpPr>
        <p:spPr>
          <a:xfrm>
            <a:off x="5978691" y="6787919"/>
            <a:ext cx="2061958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TextBox 349"/>
          <p:cNvSpPr txBox="1"/>
          <p:nvPr/>
        </p:nvSpPr>
        <p:spPr>
          <a:xfrm>
            <a:off x="7175117" y="7189862"/>
            <a:ext cx="865532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5" name="Straight Connector 354"/>
          <p:cNvCxnSpPr>
            <a:stCxn id="347" idx="3"/>
            <a:endCxn id="350" idx="1"/>
          </p:cNvCxnSpPr>
          <p:nvPr/>
        </p:nvCxnSpPr>
        <p:spPr>
          <a:xfrm>
            <a:off x="1997646" y="7339409"/>
            <a:ext cx="5177471" cy="43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6" name="Straight Connector 355"/>
          <p:cNvCxnSpPr>
            <a:stCxn id="346" idx="3"/>
            <a:endCxn id="349" idx="1"/>
          </p:cNvCxnSpPr>
          <p:nvPr/>
        </p:nvCxnSpPr>
        <p:spPr>
          <a:xfrm>
            <a:off x="1997646" y="6937466"/>
            <a:ext cx="3981045" cy="43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8" name="TextBox 357"/>
          <p:cNvSpPr txBox="1"/>
          <p:nvPr/>
        </p:nvSpPr>
        <p:spPr>
          <a:xfrm>
            <a:off x="8088707" y="5311941"/>
            <a:ext cx="10305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TextBox 358"/>
          <p:cNvSpPr txBox="1"/>
          <p:nvPr/>
        </p:nvSpPr>
        <p:spPr>
          <a:xfrm>
            <a:off x="8088707" y="5914286"/>
            <a:ext cx="1449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teosarcoma</a:t>
            </a:r>
            <a:endParaRPr lang="en-GB" sz="1400" dirty="0">
              <a:solidFill>
                <a:srgbClr val="FF99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TextBox 359"/>
          <p:cNvSpPr txBox="1"/>
          <p:nvPr/>
        </p:nvSpPr>
        <p:spPr>
          <a:xfrm>
            <a:off x="3718322" y="7493297"/>
            <a:ext cx="3004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01929" y="7558365"/>
            <a:ext cx="7648575" cy="1524000"/>
          </a:xfrm>
          <a:prstGeom prst="rect">
            <a:avLst/>
          </a:prstGeom>
        </p:spPr>
      </p:pic>
      <p:sp>
        <p:nvSpPr>
          <p:cNvPr id="361" name="TextBox 360"/>
          <p:cNvSpPr txBox="1"/>
          <p:nvPr/>
        </p:nvSpPr>
        <p:spPr>
          <a:xfrm rot="16200000">
            <a:off x="3642329" y="7889690"/>
            <a:ext cx="9652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pth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TextBox 361"/>
          <p:cNvSpPr txBox="1"/>
          <p:nvPr/>
        </p:nvSpPr>
        <p:spPr>
          <a:xfrm>
            <a:off x="10725979" y="7703440"/>
            <a:ext cx="10305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TextBox 362"/>
          <p:cNvSpPr txBox="1"/>
          <p:nvPr/>
        </p:nvSpPr>
        <p:spPr>
          <a:xfrm>
            <a:off x="10149625" y="7953543"/>
            <a:ext cx="1449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teosarcoma</a:t>
            </a:r>
            <a:endParaRPr lang="en-GB" sz="1400" dirty="0">
              <a:solidFill>
                <a:srgbClr val="FF99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TextBox 363"/>
          <p:cNvSpPr txBox="1"/>
          <p:nvPr/>
        </p:nvSpPr>
        <p:spPr>
          <a:xfrm>
            <a:off x="4671950" y="9084072"/>
            <a:ext cx="3087750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TextBox 364"/>
          <p:cNvSpPr txBox="1"/>
          <p:nvPr/>
        </p:nvSpPr>
        <p:spPr>
          <a:xfrm>
            <a:off x="4671950" y="9486015"/>
            <a:ext cx="1817750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TextBox 365"/>
          <p:cNvSpPr txBox="1"/>
          <p:nvPr/>
        </p:nvSpPr>
        <p:spPr>
          <a:xfrm>
            <a:off x="9702799" y="9088414"/>
            <a:ext cx="1877685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7" name="TextBox 366"/>
          <p:cNvSpPr txBox="1"/>
          <p:nvPr/>
        </p:nvSpPr>
        <p:spPr>
          <a:xfrm>
            <a:off x="9702799" y="9490357"/>
            <a:ext cx="1877686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8" name="Straight Connector 367"/>
          <p:cNvCxnSpPr>
            <a:stCxn id="365" idx="3"/>
            <a:endCxn id="367" idx="1"/>
          </p:cNvCxnSpPr>
          <p:nvPr/>
        </p:nvCxnSpPr>
        <p:spPr>
          <a:xfrm>
            <a:off x="6489700" y="9639904"/>
            <a:ext cx="3213099" cy="43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9" name="Straight Connector 368"/>
          <p:cNvCxnSpPr>
            <a:stCxn id="364" idx="3"/>
            <a:endCxn id="366" idx="1"/>
          </p:cNvCxnSpPr>
          <p:nvPr/>
        </p:nvCxnSpPr>
        <p:spPr>
          <a:xfrm>
            <a:off x="7759700" y="9237961"/>
            <a:ext cx="1943099" cy="43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0" name="TextBox 369"/>
          <p:cNvSpPr txBox="1"/>
          <p:nvPr/>
        </p:nvSpPr>
        <p:spPr>
          <a:xfrm>
            <a:off x="65179" y="9658275"/>
            <a:ext cx="3004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0972" y="9842941"/>
            <a:ext cx="7724775" cy="1609725"/>
          </a:xfrm>
          <a:prstGeom prst="rect">
            <a:avLst/>
          </a:prstGeom>
        </p:spPr>
      </p:pic>
      <p:sp>
        <p:nvSpPr>
          <p:cNvPr id="371" name="TextBox 370"/>
          <p:cNvSpPr txBox="1"/>
          <p:nvPr/>
        </p:nvSpPr>
        <p:spPr>
          <a:xfrm rot="16200000">
            <a:off x="36851" y="10190334"/>
            <a:ext cx="9652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pth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TextBox 371"/>
          <p:cNvSpPr txBox="1"/>
          <p:nvPr/>
        </p:nvSpPr>
        <p:spPr>
          <a:xfrm>
            <a:off x="548677" y="8367505"/>
            <a:ext cx="305993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MEM218</a:t>
            </a:r>
          </a:p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3’ Alternative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lice Site)</a:t>
            </a:r>
            <a:endParaRPr lang="en-GB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TextBox 372"/>
          <p:cNvSpPr txBox="1"/>
          <p:nvPr/>
        </p:nvSpPr>
        <p:spPr>
          <a:xfrm>
            <a:off x="8040649" y="10150478"/>
            <a:ext cx="10305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4" name="TextBox 373"/>
          <p:cNvSpPr txBox="1"/>
          <p:nvPr/>
        </p:nvSpPr>
        <p:spPr>
          <a:xfrm>
            <a:off x="8079733" y="10642761"/>
            <a:ext cx="1449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teosarcoma</a:t>
            </a:r>
            <a:endParaRPr lang="en-GB" sz="1400" dirty="0">
              <a:solidFill>
                <a:srgbClr val="FF99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TextBox 374"/>
          <p:cNvSpPr txBox="1"/>
          <p:nvPr/>
        </p:nvSpPr>
        <p:spPr>
          <a:xfrm>
            <a:off x="1132114" y="11467474"/>
            <a:ext cx="671286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TextBox 375"/>
          <p:cNvSpPr txBox="1"/>
          <p:nvPr/>
        </p:nvSpPr>
        <p:spPr>
          <a:xfrm>
            <a:off x="1132114" y="11869417"/>
            <a:ext cx="671286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TextBox 376"/>
          <p:cNvSpPr txBox="1"/>
          <p:nvPr/>
        </p:nvSpPr>
        <p:spPr>
          <a:xfrm>
            <a:off x="3346706" y="11471816"/>
            <a:ext cx="883944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TextBox 377"/>
          <p:cNvSpPr txBox="1"/>
          <p:nvPr/>
        </p:nvSpPr>
        <p:spPr>
          <a:xfrm>
            <a:off x="5829301" y="11873759"/>
            <a:ext cx="1066800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9" name="Straight Connector 378"/>
          <p:cNvCxnSpPr>
            <a:stCxn id="375" idx="3"/>
            <a:endCxn id="377" idx="1"/>
          </p:cNvCxnSpPr>
          <p:nvPr/>
        </p:nvCxnSpPr>
        <p:spPr>
          <a:xfrm>
            <a:off x="1803400" y="11621363"/>
            <a:ext cx="1543306" cy="43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1" name="TextBox 380"/>
          <p:cNvSpPr txBox="1"/>
          <p:nvPr/>
        </p:nvSpPr>
        <p:spPr>
          <a:xfrm>
            <a:off x="7331263" y="11467474"/>
            <a:ext cx="671286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TextBox 381"/>
          <p:cNvSpPr txBox="1"/>
          <p:nvPr/>
        </p:nvSpPr>
        <p:spPr>
          <a:xfrm>
            <a:off x="7331263" y="11869417"/>
            <a:ext cx="671286" cy="307777"/>
          </a:xfrm>
          <a:prstGeom prst="rect">
            <a:avLst/>
          </a:prstGeom>
          <a:pattFill prst="wdUpDiag">
            <a:fgClr>
              <a:schemeClr val="bg1">
                <a:lumMod val="85000"/>
              </a:schemeClr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3" name="Straight Connector 382"/>
          <p:cNvCxnSpPr>
            <a:stCxn id="376" idx="3"/>
            <a:endCxn id="378" idx="1"/>
          </p:cNvCxnSpPr>
          <p:nvPr/>
        </p:nvCxnSpPr>
        <p:spPr>
          <a:xfrm>
            <a:off x="1803400" y="12023306"/>
            <a:ext cx="4025901" cy="43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4" name="Straight Connector 383"/>
          <p:cNvCxnSpPr>
            <a:stCxn id="377" idx="3"/>
            <a:endCxn id="381" idx="1"/>
          </p:cNvCxnSpPr>
          <p:nvPr/>
        </p:nvCxnSpPr>
        <p:spPr>
          <a:xfrm flipV="1">
            <a:off x="4230650" y="11621363"/>
            <a:ext cx="3100613" cy="43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5" name="Straight Connector 384"/>
          <p:cNvCxnSpPr>
            <a:stCxn id="378" idx="3"/>
            <a:endCxn id="382" idx="1"/>
          </p:cNvCxnSpPr>
          <p:nvPr/>
        </p:nvCxnSpPr>
        <p:spPr>
          <a:xfrm flipV="1">
            <a:off x="6896101" y="12023306"/>
            <a:ext cx="435162" cy="43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6" name="TextBox 385"/>
          <p:cNvSpPr txBox="1"/>
          <p:nvPr/>
        </p:nvSpPr>
        <p:spPr>
          <a:xfrm>
            <a:off x="8815863" y="10950139"/>
            <a:ext cx="305993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PNE1</a:t>
            </a:r>
          </a:p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Mutually Exclusive Exon)</a:t>
            </a:r>
            <a:endParaRPr lang="en-GB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TextBox 386"/>
          <p:cNvSpPr txBox="1"/>
          <p:nvPr/>
        </p:nvSpPr>
        <p:spPr>
          <a:xfrm>
            <a:off x="3666596" y="12271361"/>
            <a:ext cx="3004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Picture 6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79299" y="12335425"/>
            <a:ext cx="7301185" cy="1966515"/>
          </a:xfrm>
          <a:prstGeom prst="rect">
            <a:avLst/>
          </a:prstGeom>
        </p:spPr>
      </p:pic>
      <p:sp>
        <p:nvSpPr>
          <p:cNvPr id="388" name="TextBox 387"/>
          <p:cNvSpPr txBox="1"/>
          <p:nvPr/>
        </p:nvSpPr>
        <p:spPr>
          <a:xfrm rot="16200000">
            <a:off x="3642329" y="13001027"/>
            <a:ext cx="9652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pth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TextBox 388"/>
          <p:cNvSpPr txBox="1"/>
          <p:nvPr/>
        </p:nvSpPr>
        <p:spPr>
          <a:xfrm>
            <a:off x="10130820" y="12271361"/>
            <a:ext cx="1449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teosarcoma</a:t>
            </a:r>
            <a:endParaRPr lang="en-GB" sz="1400" dirty="0">
              <a:solidFill>
                <a:srgbClr val="FF99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3" name="TextBox 392"/>
          <p:cNvSpPr txBox="1"/>
          <p:nvPr/>
        </p:nvSpPr>
        <p:spPr>
          <a:xfrm>
            <a:off x="806419" y="12862230"/>
            <a:ext cx="305993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BP1</a:t>
            </a:r>
          </a:p>
          <a:p>
            <a:pPr algn="ctr"/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Four 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vents)</a:t>
            </a:r>
            <a:endParaRPr lang="en-GB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13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5</TotalTime>
  <Words>82</Words>
  <Application>Microsoft Office PowerPoint</Application>
  <PresentationFormat>Custom</PresentationFormat>
  <Paragraphs>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East Ang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ll Green (MED)</dc:creator>
  <cp:lastModifiedBy>Darrell Green (MED - Staff)</cp:lastModifiedBy>
  <cp:revision>82</cp:revision>
  <dcterms:created xsi:type="dcterms:W3CDTF">2017-04-04T08:45:42Z</dcterms:created>
  <dcterms:modified xsi:type="dcterms:W3CDTF">2019-10-11T10:58:33Z</dcterms:modified>
</cp:coreProperties>
</file>